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5"/>
  </p:notesMasterIdLst>
  <p:sldIdLst>
    <p:sldId id="1113" r:id="rId2"/>
    <p:sldId id="1073" r:id="rId3"/>
    <p:sldId id="1095" r:id="rId4"/>
    <p:sldId id="1107" r:id="rId5"/>
    <p:sldId id="1100" r:id="rId6"/>
    <p:sldId id="1108" r:id="rId7"/>
    <p:sldId id="1104" r:id="rId8"/>
    <p:sldId id="1109" r:id="rId9"/>
    <p:sldId id="1110" r:id="rId10"/>
    <p:sldId id="1111" r:id="rId11"/>
    <p:sldId id="1112" r:id="rId12"/>
    <p:sldId id="1058" r:id="rId13"/>
    <p:sldId id="1078" r:id="rId14"/>
  </p:sldIdLst>
  <p:sldSz cx="18288000" cy="10287000"/>
  <p:notesSz cx="6858000" cy="9144000"/>
  <p:embeddedFontLst>
    <p:embeddedFont>
      <p:font typeface="Assistant" pitchFamily="2" charset="-79"/>
      <p:regular r:id="rId16"/>
      <p:bold r:id="rId17"/>
    </p:embeddedFont>
    <p:embeddedFont>
      <p:font typeface="Assistant Bold" charset="-79"/>
      <p:regular r:id="rId18"/>
      <p:bold r:id="rId19"/>
    </p:embeddedFont>
    <p:embeddedFont>
      <p:font typeface="Assistant ExtraBold" pitchFamily="2" charset="-79"/>
      <p:bold r:id="rId20"/>
    </p:embeddedFont>
    <p:embeddedFont>
      <p:font typeface="Assistant Regular" charset="-79"/>
      <p:regular r:id="rId21"/>
    </p:embeddedFont>
    <p:embeddedFont>
      <p:font typeface="Assistant SemiBold" pitchFamily="2" charset="-79"/>
      <p:bold r:id="rId22"/>
    </p:embeddedFont>
    <p:embeddedFont>
      <p:font typeface="Calibri" panose="020F0502020204030204" pitchFamily="34" charset="0"/>
      <p:regular r:id="rId23"/>
      <p:bold r:id="rId24"/>
      <p:italic r:id="rId25"/>
      <p:boldItalic r:id="rId26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3.fntdata"/><Relationship Id="rId26" Type="http://schemas.openxmlformats.org/officeDocument/2006/relationships/font" Target="fonts/font11.fntdata"/><Relationship Id="rId3" Type="http://schemas.openxmlformats.org/officeDocument/2006/relationships/slide" Target="slides/slide2.xml"/><Relationship Id="rId21" Type="http://schemas.openxmlformats.org/officeDocument/2006/relationships/font" Target="fonts/font6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2.fntdata"/><Relationship Id="rId25" Type="http://schemas.openxmlformats.org/officeDocument/2006/relationships/font" Target="fonts/font10.fntdata"/><Relationship Id="rId2" Type="http://schemas.openxmlformats.org/officeDocument/2006/relationships/slide" Target="slides/slide1.xml"/><Relationship Id="rId16" Type="http://schemas.openxmlformats.org/officeDocument/2006/relationships/font" Target="fonts/font1.fntdata"/><Relationship Id="rId20" Type="http://schemas.openxmlformats.org/officeDocument/2006/relationships/font" Target="fonts/font5.fntdata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9.fntdata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23" Type="http://schemas.openxmlformats.org/officeDocument/2006/relationships/font" Target="fonts/font8.fntdata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font" Target="fonts/font4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7.fntdata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89142604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4804426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0194874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4804934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67602360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97512920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90068316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47418530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4727134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7" Type="http://schemas.openxmlformats.org/officeDocument/2006/relationships/hyperlink" Target="https://www.ajokeaday.com/" TargetMode="Externa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6" Type="http://schemas.openxmlformats.org/officeDocument/2006/relationships/hyperlink" Target="https://www.cultureamp.com/blog/funny-jokes-for-the-workplace" TargetMode="External"/><Relationship Id="rId5" Type="http://schemas.openxmlformats.org/officeDocument/2006/relationships/hyperlink" Target="https://parade.com/940979/kelseypelzer/best-dad-jokes/" TargetMode="External"/><Relationship Id="rId4" Type="http://schemas.openxmlformats.org/officeDocument/2006/relationships/hyperlink" Target="https://www.countryliving.com/life/a27452412/best-dad-jokes/" TargetMode="Externa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sv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sv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2069383"/>
            <a:chOff x="1573698" y="-152998"/>
            <a:chExt cx="7219847" cy="1987255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1846660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Session #16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STRESS MANAGEMENT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Laughter and Health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2278117"/>
            <a:ext cx="10446270" cy="89562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Laughing is great stress relief and it also has a strong positive effect on health!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 Regular" charset="-79"/>
                <a:cs typeface="Assistant Regular" charset="-79"/>
              </a:rPr>
              <a:t>Distracts you from stress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 Regular" charset="-79"/>
                <a:cs typeface="Assistant Regular" charset="-79"/>
              </a:rPr>
              <a:t>Stabilizes blood sugar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 Regular" charset="-79"/>
                <a:cs typeface="Assistant Regular" charset="-79"/>
              </a:rPr>
              <a:t>Balances hormonal response to stress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 Regular" charset="-79"/>
                <a:cs typeface="Assistant Regular" charset="-79"/>
              </a:rPr>
              <a:t>Reduces hunger cravings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 Regular" charset="-79"/>
                <a:cs typeface="Assistant Regular" charset="-79"/>
              </a:rPr>
              <a:t>Reduces fat storage signaling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 Regular" charset="-79"/>
                <a:cs typeface="Assistant Regular" charset="-79"/>
              </a:rPr>
              <a:t>Feels good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 Regular" charset="-79"/>
                <a:cs typeface="Assistant Regular" charset="-79"/>
              </a:rPr>
              <a:t>Burns calories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 Regular" charset="-79"/>
                <a:cs typeface="Assistant Regular" charset="-79"/>
              </a:rPr>
              <a:t>Helps you bond with loves ones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17" name="Picture 2" descr="Kittens in a pineapple suit">
            <a:extLst>
              <a:ext uri="{FF2B5EF4-FFF2-40B4-BE49-F238E27FC236}">
                <a16:creationId xmlns:a16="http://schemas.microsoft.com/office/drawing/2014/main" id="{02C41A18-92C2-4797-9012-C4E6B931B4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5" r="3235"/>
          <a:stretch/>
        </p:blipFill>
        <p:spPr bwMode="auto">
          <a:xfrm>
            <a:off x="11742517" y="2832659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38349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Tell us a Joke!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2278117"/>
            <a:ext cx="10446270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is your favorite Joke?</a:t>
            </a:r>
          </a:p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	-  Put your favorite (clean) joke in the chat!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are your favorite sources for jokes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17" name="Picture 2" descr="Close-up portrait of happy corgi">
            <a:extLst>
              <a:ext uri="{FF2B5EF4-FFF2-40B4-BE49-F238E27FC236}">
                <a16:creationId xmlns:a16="http://schemas.microsoft.com/office/drawing/2014/main" id="{02C41A18-92C2-4797-9012-C4E6B931B4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173" b="25173"/>
          <a:stretch/>
        </p:blipFill>
        <p:spPr bwMode="auto">
          <a:xfrm>
            <a:off x="11742517" y="2832659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C7BEA37-593D-4662-AB31-9C06C361308F}"/>
              </a:ext>
            </a:extLst>
          </p:cNvPr>
          <p:cNvSpPr txBox="1"/>
          <p:nvPr/>
        </p:nvSpPr>
        <p:spPr>
          <a:xfrm>
            <a:off x="1600199" y="4991100"/>
            <a:ext cx="10142317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800" dirty="0">
                <a:hlinkClick r:id="rId4"/>
              </a:rPr>
              <a:t>https://www.countryliving.com/life/a27452412/best-dad-jokes/</a:t>
            </a:r>
            <a:r>
              <a:rPr lang="en-US" sz="2800" dirty="0"/>
              <a:t>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2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800" dirty="0">
                <a:hlinkClick r:id="rId5"/>
              </a:rPr>
              <a:t>https://parade.com/940979/kelseypelzer/best-dad-jokes/</a:t>
            </a:r>
            <a:endParaRPr lang="en-US" sz="280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2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800" dirty="0">
                <a:hlinkClick r:id="rId6"/>
              </a:rPr>
              <a:t>https://www.cultureamp.com/blog/funny-jokes-for-the-workplace</a:t>
            </a:r>
            <a:endParaRPr lang="en-US" sz="280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280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2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800" dirty="0"/>
              <a:t>Go here for a NEW joke everyday! </a:t>
            </a:r>
            <a:r>
              <a:rPr lang="en-US" sz="2800" dirty="0">
                <a:hlinkClick r:id="rId7"/>
              </a:rPr>
              <a:t>https://www.ajokeaday.com/</a:t>
            </a:r>
            <a:r>
              <a:rPr lang="en-US" sz="28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1402027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87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Your Lifestyle, in Control!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health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to get in 90 min of moderate or vigorous exercise </a:t>
            </a:r>
            <a:r>
              <a:rPr lang="en-US" sz="3200" b="1" i="1" dirty="0">
                <a:latin typeface="Assistant" pitchFamily="2" charset="-79"/>
                <a:cs typeface="Assistant" pitchFamily="2" charset="-79"/>
              </a:rPr>
              <a:t>a week </a:t>
            </a:r>
            <a:r>
              <a:rPr lang="en-US" sz="3200" dirty="0">
                <a:latin typeface="Assistant" pitchFamily="2" charset="-79"/>
                <a:cs typeface="Assistant" pitchFamily="2" charset="-79"/>
              </a:rPr>
              <a:t>by our next session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your total active time over 200 min this week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Keep up your steps, reduce sedentary time– get all 9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Practice Good sleep Hygiene and other Stress Resilience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Build up strength to stay on track even when life challenges you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Bring in a joke to share with the group next time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59923" y="8313008"/>
            <a:ext cx="1112287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Taking care of yourself comes first</a:t>
            </a:r>
          </a:p>
          <a:p>
            <a:r>
              <a:rPr lang="en-US" sz="2800" dirty="0"/>
              <a:t>Mind and body, your needs are your top priority. It can be hard to say no but you will feel better if you do what is right for you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04095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</a:t>
            </a:r>
            <a:r>
              <a:rPr lang="en-US" sz="3200" b="1">
                <a:latin typeface="Assistant" pitchFamily="2" charset="-79"/>
                <a:cs typeface="Assistant" pitchFamily="2" charset="-79"/>
              </a:rPr>
              <a:t>next month:</a:t>
            </a:r>
            <a:endParaRPr lang="en-US" sz="3200" b="1" dirty="0">
              <a:latin typeface="Assistant" pitchFamily="2" charset="-79"/>
              <a:cs typeface="Assistant" pitchFamily="2" charset="-79"/>
            </a:endParaRP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crease your physical activity! </a:t>
            </a:r>
          </a:p>
          <a:p>
            <a:pPr marL="514350" indent="-514350">
              <a:buFont typeface="+mj-lt"/>
              <a:buAutoNum type="arabicPeriod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activity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495800" y="8103233"/>
            <a:ext cx="12316505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r>
              <a:rPr lang="en-US" sz="3000" dirty="0"/>
              <a:t>Laugh! Sleep! Hydrate! Walk! Eat fruits and veggies! That’s a recipe for a healthy happy life!</a:t>
            </a:r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THE LAST 2 WEEKS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health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Tx/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Practice Mindfulness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increase your moderate and vigorous exerci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All about Stress!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426725" y="2467178"/>
            <a:ext cx="12125724" cy="46474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How often do you feel stressed? (select one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ll the time, I am always stresse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’m stressed out most of the ti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have a fair amount of routine stres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ometime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get stressed infrequentl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rarely get stresse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ver feel stressed</a:t>
            </a:r>
          </a:p>
        </p:txBody>
      </p:sp>
      <p:pic>
        <p:nvPicPr>
          <p:cNvPr id="23" name="Picture 22" descr="Torn rope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43" r="20843"/>
          <a:stretch/>
        </p:blipFill>
        <p:spPr>
          <a:xfrm>
            <a:off x="12333492" y="2273010"/>
            <a:ext cx="5149921" cy="5888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8426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Different Setting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426725" y="2467178"/>
            <a:ext cx="10385918" cy="72943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kinds of things cause me stress? (select all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Special occasions (e.g. weddings &amp; anniversaries)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Sad events (e.g. funerals)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Major life events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Health issues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Work demands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Difficult conversations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Family changes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Emotional experiences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Needing to rush, being in a hurry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Leaving your comfort zone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Other (discuss)</a:t>
            </a:r>
          </a:p>
        </p:txBody>
      </p:sp>
      <p:pic>
        <p:nvPicPr>
          <p:cNvPr id="23" name="Picture 22" descr="Wedding chairs in the church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3" r="20815"/>
          <a:stretch/>
        </p:blipFill>
        <p:spPr>
          <a:xfrm>
            <a:off x="11575128" y="2169464"/>
            <a:ext cx="6198374" cy="54429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60890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igns of Str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360181" y="2259782"/>
            <a:ext cx="11028718" cy="84487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How do you know you are stressed? (select All)</a:t>
            </a:r>
            <a:endParaRPr lang="en-US" sz="3600" b="1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Heart starts pounds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Feeling tired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ant to isolate from people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hort fuse, temper rises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et hungry/eat between meals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Feel dizzy or lightheaded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tart talking too much/too fast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>
              <a:lnSpc>
                <a:spcPct val="150000"/>
              </a:lnSpc>
            </a:pPr>
            <a:endParaRPr lang="en-US" sz="3200" b="1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23" name="Picture 22" descr="Alarm clocks with mouths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15" r="20615"/>
          <a:stretch/>
        </p:blipFill>
        <p:spPr>
          <a:xfrm>
            <a:off x="12538226" y="2026994"/>
            <a:ext cx="5149921" cy="5888363"/>
          </a:xfrm>
          <a:prstGeom prst="rect">
            <a:avLst/>
          </a:prstGeom>
        </p:spPr>
      </p:pic>
      <p:pic>
        <p:nvPicPr>
          <p:cNvPr id="10" name="Graphic 9" descr="Badge 1 with solid fill">
            <a:extLst>
              <a:ext uri="{FF2B5EF4-FFF2-40B4-BE49-F238E27FC236}">
                <a16:creationId xmlns:a16="http://schemas.microsoft.com/office/drawing/2014/main" id="{C6711588-5181-4DB3-AFE7-1F32F25068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10775398" y="8280295"/>
            <a:ext cx="1707657" cy="170765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F79CF9A-7598-4A5A-B5EA-B42573FE9727}"/>
              </a:ext>
            </a:extLst>
          </p:cNvPr>
          <p:cNvSpPr txBox="1"/>
          <p:nvPr/>
        </p:nvSpPr>
        <p:spPr>
          <a:xfrm>
            <a:off x="12663607" y="8164627"/>
            <a:ext cx="494518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What is usually the FIRST thing you notice about your self that let’s you know when you are feeling stressed?</a:t>
            </a:r>
          </a:p>
          <a:p>
            <a:endParaRPr lang="en-US" sz="2400" dirty="0"/>
          </a:p>
          <a:p>
            <a:r>
              <a:rPr lang="en-US" sz="2400" b="1" u="sng" dirty="0"/>
              <a:t>Tell us in the chat!</a:t>
            </a:r>
          </a:p>
        </p:txBody>
      </p:sp>
    </p:spTree>
    <p:extLst>
      <p:ext uri="{BB962C8B-B14F-4D97-AF65-F5344CB8AC3E}">
        <p14:creationId xmlns:p14="http://schemas.microsoft.com/office/powerpoint/2010/main" val="30474887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ome stress good, too much is bad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360181" y="1988088"/>
            <a:ext cx="11028718" cy="84487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Good stress – keeps life INTERESTING</a:t>
            </a:r>
            <a:endParaRPr lang="en-US" sz="3600" b="1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creasing your heart rate from exercise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uspense in a good book or movie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peaking in front of a lot of people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ooking down a valley after climbing to the top of a trail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Planning your children or grandchildren’s wedding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600" b="1" dirty="0">
                <a:latin typeface="Assistant Regular" charset="-79"/>
                <a:cs typeface="Assistant Regular" charset="-79"/>
              </a:rPr>
              <a:t>Bad stress – more than you can handle</a:t>
            </a:r>
            <a:endParaRPr lang="en-US" sz="3600" b="1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verwhelms you, makes you less intentional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asts a long time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Harms outweigh the benefits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23" name="Picture 22" descr="Person on a cliff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71" r="21671"/>
          <a:stretch/>
        </p:blipFill>
        <p:spPr>
          <a:xfrm>
            <a:off x="12538226" y="2026994"/>
            <a:ext cx="5149921" cy="588836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E61AD81-EE6D-4B04-B764-FC3F252C76DC}"/>
              </a:ext>
            </a:extLst>
          </p:cNvPr>
          <p:cNvSpPr txBox="1"/>
          <p:nvPr/>
        </p:nvSpPr>
        <p:spPr>
          <a:xfrm>
            <a:off x="12623581" y="8288387"/>
            <a:ext cx="5149921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SCARY and A LOT OF WORK</a:t>
            </a:r>
          </a:p>
          <a:p>
            <a:pPr marL="342900" indent="-342900">
              <a:buFont typeface="Wingdings" panose="05000000000000000000" pitchFamily="2" charset="2"/>
              <a:buChar char="à"/>
            </a:pPr>
            <a:r>
              <a:rPr lang="en-US" sz="2400" b="1" u="sng" dirty="0"/>
              <a:t>but also beautiful and fun.</a:t>
            </a:r>
          </a:p>
          <a:p>
            <a:r>
              <a:rPr lang="en-US" sz="2400" b="1" u="sng" dirty="0"/>
              <a:t> </a:t>
            </a:r>
          </a:p>
          <a:p>
            <a:pPr algn="ctr"/>
            <a:r>
              <a:rPr lang="en-US" sz="2800" dirty="0"/>
              <a:t>Good stress.</a:t>
            </a:r>
          </a:p>
        </p:txBody>
      </p:sp>
    </p:spTree>
    <p:extLst>
      <p:ext uri="{BB962C8B-B14F-4D97-AF65-F5344CB8AC3E}">
        <p14:creationId xmlns:p14="http://schemas.microsoft.com/office/powerpoint/2010/main" val="35425135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Resilient to Str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Group of people doing push ups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1" r="5301"/>
          <a:stretch/>
        </p:blipFill>
        <p:spPr bwMode="auto">
          <a:xfrm>
            <a:off x="11806451" y="3390900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446270" cy="8402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You can’t avoid all stress, but you can keep yourself strong and resilient.</a:t>
            </a:r>
          </a:p>
          <a:p>
            <a:pPr lvl="1"/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Ways to stay strong to handle normal stress:</a:t>
            </a:r>
          </a:p>
          <a:p>
            <a:pPr marL="1200150" lvl="1" indent="-742950">
              <a:buFont typeface="+mj-lt"/>
              <a:buAutoNum type="arabicPeriod"/>
            </a:pPr>
            <a:r>
              <a:rPr lang="en-US" sz="3600" dirty="0">
                <a:latin typeface="Assistant Regular" charset="-79"/>
                <a:cs typeface="Assistant Regular" charset="-79"/>
              </a:rPr>
              <a:t>Getting enough sleep regularly</a:t>
            </a:r>
          </a:p>
          <a:p>
            <a:pPr marL="1200150" lvl="1" indent="-742950">
              <a:buFont typeface="+mj-lt"/>
              <a:buAutoNum type="arabicPeriod"/>
            </a:pPr>
            <a:r>
              <a:rPr lang="en-US" sz="3600" dirty="0">
                <a:latin typeface="Assistant Regular" charset="-79"/>
                <a:cs typeface="Assistant Regular" charset="-79"/>
              </a:rPr>
              <a:t>Practicing Mindfulness</a:t>
            </a:r>
          </a:p>
          <a:p>
            <a:pPr marL="1200150" lvl="1" indent="-742950">
              <a:buFont typeface="+mj-lt"/>
              <a:buAutoNum type="arabicPeriod"/>
            </a:pPr>
            <a:r>
              <a:rPr lang="en-US" sz="3600" dirty="0">
                <a:latin typeface="Assistant Regular" charset="-79"/>
                <a:cs typeface="Assistant Regular" charset="-79"/>
              </a:rPr>
              <a:t>Getting Exercise</a:t>
            </a:r>
          </a:p>
          <a:p>
            <a:pPr marL="1200150" lvl="1" indent="-742950">
              <a:buFont typeface="+mj-lt"/>
              <a:buAutoNum type="arabicPeriod"/>
            </a:pPr>
            <a:r>
              <a:rPr lang="en-US" sz="3600" dirty="0">
                <a:latin typeface="Assistant Regular" charset="-79"/>
                <a:cs typeface="Assistant Regular" charset="-79"/>
              </a:rPr>
              <a:t>Balancing blood pressure with healthy diet</a:t>
            </a:r>
          </a:p>
          <a:p>
            <a:pPr marL="1200150" lvl="1" indent="-742950">
              <a:buFont typeface="+mj-lt"/>
              <a:buAutoNum type="arabicPeriod"/>
            </a:pPr>
            <a:r>
              <a:rPr lang="en-US" sz="3600" b="1" u="sng" dirty="0">
                <a:latin typeface="Assistant Regular" charset="-79"/>
                <a:cs typeface="Assistant Regular" charset="-79"/>
              </a:rPr>
              <a:t>Other (discuss, and add ideas in the chat)</a:t>
            </a:r>
          </a:p>
          <a:p>
            <a:pPr marL="1200150" lvl="1" indent="-742950">
              <a:buFont typeface="+mj-lt"/>
              <a:buAutoNum type="arabicPeriod"/>
            </a:pPr>
            <a:r>
              <a:rPr lang="en-US" sz="3600" i="1" dirty="0">
                <a:latin typeface="Assistant Regular" charset="-79"/>
                <a:cs typeface="Assistant Regular" charset="-79"/>
              </a:rPr>
              <a:t>More ideas in this week’s handout!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5503772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Balancing Str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Woman wearing colorful shirt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23" r="5323"/>
          <a:stretch/>
        </p:blipFill>
        <p:spPr bwMode="auto">
          <a:xfrm>
            <a:off x="12058899" y="3390900"/>
            <a:ext cx="5938977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698718" cy="88793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en health is your priority, other things need to become lower priorities.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200150" lvl="1" indent="-742950">
              <a:buFont typeface="+mj-lt"/>
              <a:buAutoNum type="arabicPeriod"/>
            </a:pPr>
            <a:r>
              <a:rPr lang="en-US" sz="3600" dirty="0">
                <a:latin typeface="Assistant Regular" charset="-79"/>
                <a:cs typeface="Assistant Regular" charset="-79"/>
              </a:rPr>
              <a:t>Prioritize stresses with NET BENEFIT</a:t>
            </a:r>
          </a:p>
          <a:p>
            <a:pPr marL="1657350" lvl="2" indent="-7429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en-US" sz="3200" dirty="0">
                <a:latin typeface="Assistant Regular" charset="-79"/>
                <a:cs typeface="Assistant Regular" charset="-79"/>
              </a:rPr>
              <a:t>When it’s hard work, but worth it</a:t>
            </a:r>
          </a:p>
          <a:p>
            <a:pPr marL="1200150" lvl="1" indent="-742950">
              <a:buFont typeface="+mj-lt"/>
              <a:buAutoNum type="arabicPeriod"/>
            </a:pPr>
            <a:r>
              <a:rPr lang="en-US" sz="3600" dirty="0">
                <a:latin typeface="Assistant Regular" charset="-79"/>
                <a:cs typeface="Assistant Regular" charset="-79"/>
              </a:rPr>
              <a:t>If you can choose, eliminate unneeded bad stress</a:t>
            </a:r>
          </a:p>
          <a:p>
            <a:pPr marL="1657350" lvl="2" indent="-7429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en-US" sz="3200" dirty="0">
                <a:latin typeface="Assistant Regular" charset="-79"/>
                <a:cs typeface="Assistant Regular" charset="-79"/>
              </a:rPr>
              <a:t>If something isn’t working for you, let it go</a:t>
            </a:r>
          </a:p>
          <a:p>
            <a:pPr marL="1200150" lvl="1" indent="-742950">
              <a:buFont typeface="+mj-lt"/>
              <a:buAutoNum type="arabicPeriod"/>
            </a:pPr>
            <a:r>
              <a:rPr lang="en-US" sz="3600" dirty="0">
                <a:latin typeface="Assistant Regular" charset="-79"/>
                <a:cs typeface="Assistant Regular" charset="-79"/>
              </a:rPr>
              <a:t>If you can’t eliminate, move self-care to the front</a:t>
            </a:r>
          </a:p>
          <a:p>
            <a:pPr marL="1657350" lvl="2" indent="-7429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en-US" sz="3200" dirty="0">
                <a:latin typeface="Assistant Regular" charset="-79"/>
                <a:cs typeface="Assistant Regular" charset="-79"/>
              </a:rPr>
              <a:t>Take care of your needs first, then tackle the stress</a:t>
            </a:r>
          </a:p>
          <a:p>
            <a:pPr marL="1200150" lvl="1" indent="-742950">
              <a:buFont typeface="+mj-lt"/>
              <a:buAutoNum type="arabicPeriod"/>
            </a:pPr>
            <a:r>
              <a:rPr lang="en-US" sz="3600" dirty="0">
                <a:latin typeface="Assistant Regular" charset="-79"/>
                <a:cs typeface="Assistant Regular" charset="-79"/>
              </a:rPr>
              <a:t>Ask for support, don’t go it alone</a:t>
            </a:r>
          </a:p>
          <a:p>
            <a:pPr marL="1657350" lvl="2" indent="-742950">
              <a:buFont typeface="Wingdings" panose="05000000000000000000" pitchFamily="2" charset="2"/>
              <a:buChar char="Ø"/>
            </a:pPr>
            <a:r>
              <a:rPr lang="en-US" sz="3200" dirty="0">
                <a:latin typeface="Assistant Regular" charset="-79"/>
                <a:cs typeface="Assistant Regular" charset="-79"/>
              </a:rPr>
              <a:t>Life is tough and gives us many challenges, but you don’t have to face everything alone.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0900642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leep Hygien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446270" cy="95102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Sometimes everything feels better after a good night’s sleep– don’t you think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Wingdings" panose="05000000000000000000" pitchFamily="2" charset="2"/>
              <a:buChar char="ü"/>
            </a:pPr>
            <a:r>
              <a:rPr lang="en-US" sz="3600" dirty="0">
                <a:latin typeface="Assistant Regular" charset="-79"/>
                <a:cs typeface="Assistant Regular" charset="-79"/>
              </a:rPr>
              <a:t>7-8 hours a night</a:t>
            </a:r>
          </a:p>
          <a:p>
            <a:pPr marL="1028700" lvl="1" indent="-571500">
              <a:buFont typeface="Wingdings" panose="05000000000000000000" pitchFamily="2" charset="2"/>
              <a:buChar char="ü"/>
            </a:pPr>
            <a:r>
              <a:rPr lang="en-US" sz="3600" dirty="0">
                <a:latin typeface="Assistant Regular" charset="-79"/>
                <a:cs typeface="Assistant Regular" charset="-79"/>
              </a:rPr>
              <a:t>Going to bed at the same time</a:t>
            </a:r>
          </a:p>
          <a:p>
            <a:pPr marL="1028700" lvl="1" indent="-571500">
              <a:buFont typeface="Wingdings" panose="05000000000000000000" pitchFamily="2" charset="2"/>
              <a:buChar char="ü"/>
            </a:pPr>
            <a:r>
              <a:rPr lang="en-US" sz="3600" dirty="0">
                <a:latin typeface="Assistant Regular" charset="-79"/>
                <a:cs typeface="Assistant Regular" charset="-79"/>
              </a:rPr>
              <a:t>Going to bed before midnight</a:t>
            </a:r>
          </a:p>
          <a:p>
            <a:pPr marL="1028700" lvl="1" indent="-571500">
              <a:buFont typeface="Wingdings" panose="05000000000000000000" pitchFamily="2" charset="2"/>
              <a:buChar char="ü"/>
            </a:pPr>
            <a:r>
              <a:rPr lang="en-US" sz="3600" dirty="0">
                <a:latin typeface="Assistant Regular" charset="-79"/>
                <a:cs typeface="Assistant Regular" charset="-79"/>
              </a:rPr>
              <a:t>More than 2-3 hours since last eating</a:t>
            </a:r>
          </a:p>
          <a:p>
            <a:pPr marL="1028700" lvl="1" indent="-571500">
              <a:buFont typeface="Wingdings" panose="05000000000000000000" pitchFamily="2" charset="2"/>
              <a:buChar char="ü"/>
            </a:pPr>
            <a:r>
              <a:rPr lang="en-US" sz="3600" dirty="0">
                <a:latin typeface="Assistant Regular" charset="-79"/>
                <a:cs typeface="Assistant Regular" charset="-79"/>
              </a:rPr>
              <a:t>At least 1 hour without devices/screens</a:t>
            </a:r>
          </a:p>
          <a:p>
            <a:pPr marL="1028700" lvl="1" indent="-571500">
              <a:buFont typeface="Wingdings" panose="05000000000000000000" pitchFamily="2" charset="2"/>
              <a:buChar char="ü"/>
            </a:pPr>
            <a:r>
              <a:rPr lang="en-US" sz="3600" dirty="0">
                <a:latin typeface="Assistant Regular" charset="-79"/>
                <a:cs typeface="Assistant Regular" charset="-79"/>
              </a:rPr>
              <a:t>Dark, comfortable environment</a:t>
            </a:r>
          </a:p>
          <a:p>
            <a:pPr marL="1028700" lvl="1" indent="-571500">
              <a:buFont typeface="Wingdings" panose="05000000000000000000" pitchFamily="2" charset="2"/>
              <a:buChar char="ü"/>
            </a:pPr>
            <a:r>
              <a:rPr lang="en-US" sz="3600" dirty="0">
                <a:latin typeface="Assistant Regular" charset="-79"/>
                <a:cs typeface="Assistant Regular" charset="-79"/>
              </a:rPr>
              <a:t>Daily physical activity</a:t>
            </a:r>
          </a:p>
          <a:p>
            <a:pPr marL="1028700" lvl="1" indent="-571500">
              <a:buFont typeface="Wingdings" panose="05000000000000000000" pitchFamily="2" charset="2"/>
              <a:buChar char="ü"/>
            </a:pPr>
            <a:r>
              <a:rPr lang="en-US" sz="3600" dirty="0">
                <a:latin typeface="Assistant Regular" charset="-79"/>
                <a:cs typeface="Assistant Regular" charset="-79"/>
              </a:rPr>
              <a:t>Limit caffeine and tobacco (</a:t>
            </a:r>
            <a:r>
              <a:rPr lang="en-US" sz="3600" dirty="0" err="1">
                <a:latin typeface="Assistant Regular" charset="-79"/>
                <a:cs typeface="Assistant Regular" charset="-79"/>
              </a:rPr>
              <a:t>esp</a:t>
            </a:r>
            <a:r>
              <a:rPr lang="en-US" sz="3600" dirty="0">
                <a:latin typeface="Assistant Regular" charset="-79"/>
                <a:cs typeface="Assistant Regular" charset="-79"/>
              </a:rPr>
              <a:t> late in the day)</a:t>
            </a:r>
          </a:p>
          <a:p>
            <a:pPr marL="1028700" lvl="1" indent="-571500">
              <a:buFont typeface="Wingdings" panose="05000000000000000000" pitchFamily="2" charset="2"/>
              <a:buChar char="ü"/>
            </a:pPr>
            <a:r>
              <a:rPr lang="en-US" sz="3600" i="1" dirty="0">
                <a:latin typeface="Assistant Regular" charset="-79"/>
                <a:cs typeface="Assistant Regular" charset="-79"/>
              </a:rPr>
              <a:t>More ideas on page 5</a:t>
            </a:r>
          </a:p>
          <a:p>
            <a:pPr marL="571500" indent="-571500">
              <a:buFont typeface="Wingdings" panose="05000000000000000000" pitchFamily="2" charset="2"/>
              <a:buChar char="ü"/>
            </a:pP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Wingdings" panose="05000000000000000000" pitchFamily="2" charset="2"/>
              <a:buChar char="ü"/>
            </a:pP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17" name="Picture 2" descr="Cat sleeping on blanket">
            <a:extLst>
              <a:ext uri="{FF2B5EF4-FFF2-40B4-BE49-F238E27FC236}">
                <a16:creationId xmlns:a16="http://schemas.microsoft.com/office/drawing/2014/main" id="{B26E5343-005D-4E3A-AE8C-246EF2E970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31" b="1931"/>
          <a:stretch/>
        </p:blipFill>
        <p:spPr bwMode="auto">
          <a:xfrm>
            <a:off x="11582077" y="2832659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012E35F-0D4E-4109-8C64-591B0F500904}"/>
              </a:ext>
            </a:extLst>
          </p:cNvPr>
          <p:cNvSpPr txBox="1"/>
          <p:nvPr/>
        </p:nvSpPr>
        <p:spPr>
          <a:xfrm>
            <a:off x="12219339" y="8073918"/>
            <a:ext cx="555416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You can ask your interventionist about your sleep quality from </a:t>
            </a:r>
            <a:r>
              <a:rPr lang="en-US" sz="2400" dirty="0" err="1"/>
              <a:t>FitBit</a:t>
            </a:r>
            <a:r>
              <a:rPr lang="en-US" sz="2400" dirty="0"/>
              <a:t>. You can also self-monitor your progress in your Fitbit app!</a:t>
            </a:r>
          </a:p>
        </p:txBody>
      </p:sp>
      <p:pic>
        <p:nvPicPr>
          <p:cNvPr id="6" name="Graphic 5" descr="Badge Question Mark with solid fill">
            <a:extLst>
              <a:ext uri="{FF2B5EF4-FFF2-40B4-BE49-F238E27FC236}">
                <a16:creationId xmlns:a16="http://schemas.microsoft.com/office/drawing/2014/main" id="{41CC86A7-929E-433F-866E-620CA9DAD36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1337023" y="8216883"/>
            <a:ext cx="914400" cy="91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7240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33</TotalTime>
  <Words>1010</Words>
  <Application>Microsoft Office PowerPoint</Application>
  <PresentationFormat>Custom</PresentationFormat>
  <Paragraphs>209</Paragraphs>
  <Slides>13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3" baseType="lpstr">
      <vt:lpstr>Assistant</vt:lpstr>
      <vt:lpstr>Courier New</vt:lpstr>
      <vt:lpstr>Assistant ExtraBold</vt:lpstr>
      <vt:lpstr>Calibri</vt:lpstr>
      <vt:lpstr>Wingdings</vt:lpstr>
      <vt:lpstr>Arial</vt:lpstr>
      <vt:lpstr>Assistant Regular</vt:lpstr>
      <vt:lpstr>Assistant Bold</vt:lpstr>
      <vt:lpstr>Assistant Semi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379</cp:revision>
  <dcterms:created xsi:type="dcterms:W3CDTF">2006-08-16T00:00:00Z</dcterms:created>
  <dcterms:modified xsi:type="dcterms:W3CDTF">2023-11-03T21:15:01Z</dcterms:modified>
  <dc:identifier>DAE7nbwep5o</dc:identifier>
</cp:coreProperties>
</file>